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119813" cy="82804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0557D54-E3AE-43BC-B11D-9F97ED9D30A0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550692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000" y="4790160"/>
            <a:ext cx="550692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90A7697-FED5-43B6-9333-20E3354EF3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7680" y="193680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000" y="479016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7680" y="479016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EFEACDD-CFC4-4549-BA69-5A414DBFF4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17730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7920" y="1936800"/>
            <a:ext cx="17730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0200" y="1936800"/>
            <a:ext cx="17730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000" y="4790160"/>
            <a:ext cx="17730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7920" y="4790160"/>
            <a:ext cx="17730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0200" y="4790160"/>
            <a:ext cx="17730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9A8A6E3-2B9F-4D48-B2E7-9F3FFFF53D21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000" y="1936800"/>
            <a:ext cx="550692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BC54B70-BED9-4F38-9EE2-086BD1C8D7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550692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B41C5E6-77D3-4B6D-AD9D-257D01BB59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26870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7680" y="1936800"/>
            <a:ext cx="26870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3A67913-C9AB-42C5-8721-5A50E674E6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B650BEC-8799-48FC-A82D-8594E58969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8280" y="2571480"/>
            <a:ext cx="5200920" cy="821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F98539B-C161-43C7-BA3B-0E6502BFEA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7680" y="1936800"/>
            <a:ext cx="26870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000" y="479016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C044014-6ADD-4758-A6A4-C9A4915CCE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26870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7680" y="193680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7680" y="479016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B6CEBCB-60B3-4232-9F74-F8C5B6C3E5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000" y="193680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7680" y="1936800"/>
            <a:ext cx="26870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000" y="4790160"/>
            <a:ext cx="550692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4807580-522C-4E70-AB6F-366E6578EA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8280" y="2571480"/>
            <a:ext cx="5200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306360" y="7675560"/>
            <a:ext cx="142704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7/28/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2092320" y="7675560"/>
            <a:ext cx="193824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4386240" y="7675560"/>
            <a:ext cx="142704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fld id="{A4C05550-4090-4F25-853D-0031C197A29C}" type="slidenum">
              <a:rPr b="0" lang="en-PH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306000" y="1936800"/>
            <a:ext cx="550692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98000"/>
          </a:bodyPr>
          <a:p>
            <a:pPr marL="3358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35880" indent="-3358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35880" indent="-3358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35880" indent="-3358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35880" indent="-3358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35880" indent="-3358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35880" indent="-3358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63440" y="-108000"/>
            <a:ext cx="5794560" cy="63342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0" y="6412320"/>
            <a:ext cx="6121440" cy="191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Figure S1: Measurement of DNA damage and RAD51 expression in H9-NSC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A)</a:t>
            </a: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 H9-NSC line was irradiated at 4Gy and subjected to comet assay at indicated time. Data are given as a percentage of olive tail moment (OTM) and normalized to control (***p&lt;0.001 </a:t>
            </a:r>
            <a:r>
              <a:rPr b="0" i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versus</a:t>
            </a: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 control cells). </a:t>
            </a: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B) </a:t>
            </a: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mRNA expression of RAD51 in group 1, group 2 and H9-NSC (*p&lt;0.05). </a:t>
            </a: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. </a:t>
            </a: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The vertical scatter plot shows the log10 expression of relative quantification (RQ) values normalized to the expression before IR. Each data point represents each cell line measured in triplicate.  </a:t>
            </a: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C) </a:t>
            </a: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H9-NSC viability was measured using an MTS assay after 5 days of RI-1 treatment. </a:t>
            </a: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D)</a:t>
            </a: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 Comet assay was performed on H9-NSC treated for 24 hours with 10µM of RI-1 before 4Gy IR. Data are given as a percentage of olive tail moment (OTM) normalized to contro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